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56" r:id="rId1"/>
  </p:sldMasterIdLst>
  <p:notesMasterIdLst>
    <p:notesMasterId r:id="rId5"/>
  </p:notesMasterIdLst>
  <p:sldIdLst>
    <p:sldId id="359" r:id="rId2"/>
    <p:sldId id="365" r:id="rId3"/>
    <p:sldId id="368" r:id="rId4"/>
  </p:sldIdLst>
  <p:sldSz cx="1440021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88EB321-87BA-A0A9-B792-3ABFDC0FB5B6}" name="Yajing Zhu" initials="YZ" userId="S::yajing.zhu@ki.se::7cccb238-ea34-4673-98c2-513756bfc24e" providerId="AD"/>
  <p188:author id="{7B02A035-B895-4E04-1778-D208D2B26FF2}" name="Ivette Raices Cruz" initials="IRC" userId="S::ivette.raices.cruz@ki.se::fb636811-662a-4757-bdc7-73af7b4345d2" providerId="AD"/>
  <p188:author id="{AD367DA7-7029-56F0-AC61-132BA9C17FB0}" name="Mattias Bergqvist" initials="MB" userId="S::mattias.bergqvist@biovica.com::d0298d5f-0cb2-4d7a-8af0-ad0a35854f2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70052"/>
    <a:srgbClr val="EDEDED"/>
    <a:srgbClr val="FFFFFF"/>
    <a:srgbClr val="E9EB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06799F8-075E-4A3A-A7F6-7FBC6576F1A4}" styleName="主题样式 2 - 强调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F5AB1C69-6EDB-4FF4-983F-18BD219EF322}" styleName="中度样式 2 - 强调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DF18680-E054-41AD-8BC1-D1AEF772440D}" styleName="中度样式 2 - 强调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BDBED569-4797-4DF1-A0F4-6AAB3CD982D8}" styleName="浅色样式 3 - 强调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8799B23B-EC83-4686-B30A-512413B5E67A}" styleName="浅色样式 3 - 强调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505E3EF-67EA-436B-97B2-0124C06EBD24}" styleName="中度样式 4 - 强调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C083E6E3-FA7D-4D7B-A595-EF9225AFEA82}" styleName="浅色样式 1 - 强调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2DE63D5-997A-4646-A377-4702673A728D}" styleName="浅色样式 2 - 强调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EB344D84-9AFB-497E-A393-DC336BA19D2E}" styleName="中度样式 3 - 强调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9727"/>
    <p:restoredTop sz="95707"/>
  </p:normalViewPr>
  <p:slideViewPr>
    <p:cSldViewPr snapToGrid="0" snapToObjects="1">
      <p:cViewPr varScale="1">
        <p:scale>
          <a:sx n="56" d="100"/>
          <a:sy n="56" d="100"/>
        </p:scale>
        <p:origin x="159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40DB5F-ECD4-B440-AED0-B923C836AC0E}" type="datetimeFigureOut">
              <a:rPr kumimoji="1" lang="zh-CN" altLang="en-US" smtClean="0"/>
              <a:t>2023/7/14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008D81-CA1A-9B46-AAF6-ACC621FEF8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649454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56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1pPr>
    <a:lvl2pPr marL="457128" algn="l" defTabSz="914256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2pPr>
    <a:lvl3pPr marL="914256" algn="l" defTabSz="914256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3pPr>
    <a:lvl4pPr marL="1371384" algn="l" defTabSz="914256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4pPr>
    <a:lvl5pPr marL="1828513" algn="l" defTabSz="914256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5pPr>
    <a:lvl6pPr marL="2285641" algn="l" defTabSz="914256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6pPr>
    <a:lvl7pPr marL="2742769" algn="l" defTabSz="914256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7pPr>
    <a:lvl8pPr marL="3199897" algn="l" defTabSz="914256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8pPr>
    <a:lvl9pPr marL="3657025" algn="l" defTabSz="914256" rtl="0" eaLnBrk="1" latinLnBrk="0" hangingPunct="1">
      <a:defRPr sz="119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885950" y="1143000"/>
            <a:ext cx="30861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008D81-CA1A-9B46-AAF6-ACC621FEF872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961085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2356703"/>
            <a:ext cx="12240181" cy="501340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7563446"/>
            <a:ext cx="10800160" cy="3476717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0505D-F369-F641-B378-8C27BAB58CFD}" type="datetimeFigureOut">
              <a:rPr kumimoji="1" lang="zh-CN" altLang="en-US" smtClean="0"/>
              <a:t>2023/7/14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EAD65-65B7-DD44-9AD7-3EEB34CD8DE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7810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0505D-F369-F641-B378-8C27BAB58CFD}" type="datetimeFigureOut">
              <a:rPr kumimoji="1" lang="zh-CN" altLang="en-US" smtClean="0"/>
              <a:t>2023/7/14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EAD65-65B7-DD44-9AD7-3EEB34CD8DE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241907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766678"/>
            <a:ext cx="3105046" cy="122035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766678"/>
            <a:ext cx="9135135" cy="122035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0505D-F369-F641-B378-8C27BAB58CFD}" type="datetimeFigureOut">
              <a:rPr kumimoji="1" lang="zh-CN" altLang="en-US" smtClean="0"/>
              <a:t>2023/7/14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EAD65-65B7-DD44-9AD7-3EEB34CD8DE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821133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0505D-F369-F641-B378-8C27BAB58CFD}" type="datetimeFigureOut">
              <a:rPr kumimoji="1" lang="zh-CN" altLang="en-US" smtClean="0"/>
              <a:t>2023/7/14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EAD65-65B7-DD44-9AD7-3EEB34CD8DE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85152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3590057"/>
            <a:ext cx="12420184" cy="5990088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9636813"/>
            <a:ext cx="12420184" cy="3150046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0505D-F369-F641-B378-8C27BAB58CFD}" type="datetimeFigureOut">
              <a:rPr kumimoji="1" lang="zh-CN" altLang="en-US" smtClean="0"/>
              <a:t>2023/7/14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EAD65-65B7-DD44-9AD7-3EEB34CD8DE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50710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3833390"/>
            <a:ext cx="6120091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3833390"/>
            <a:ext cx="6120091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0505D-F369-F641-B378-8C27BAB58CFD}" type="datetimeFigureOut">
              <a:rPr kumimoji="1" lang="zh-CN" altLang="en-US" smtClean="0"/>
              <a:t>2023/7/14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EAD65-65B7-DD44-9AD7-3EEB34CD8DE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77369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66681"/>
            <a:ext cx="12420184" cy="27833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3530053"/>
            <a:ext cx="6091964" cy="1730025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5260078"/>
            <a:ext cx="6091964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3530053"/>
            <a:ext cx="6121966" cy="1730025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5260078"/>
            <a:ext cx="6121966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0505D-F369-F641-B378-8C27BAB58CFD}" type="datetimeFigureOut">
              <a:rPr kumimoji="1" lang="zh-CN" altLang="en-US" smtClean="0"/>
              <a:t>2023/7/14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EAD65-65B7-DD44-9AD7-3EEB34CD8DE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25414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0505D-F369-F641-B378-8C27BAB58CFD}" type="datetimeFigureOut">
              <a:rPr kumimoji="1" lang="zh-CN" altLang="en-US" smtClean="0"/>
              <a:t>2023/7/14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EAD65-65B7-DD44-9AD7-3EEB34CD8DE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32915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0505D-F369-F641-B378-8C27BAB58CFD}" type="datetimeFigureOut">
              <a:rPr kumimoji="1" lang="zh-CN" altLang="en-US" smtClean="0"/>
              <a:t>2023/7/14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EAD65-65B7-DD44-9AD7-3EEB34CD8DE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77486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60014"/>
            <a:ext cx="4644444" cy="3360050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073367"/>
            <a:ext cx="7290108" cy="10233485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320064"/>
            <a:ext cx="4644444" cy="800345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0505D-F369-F641-B378-8C27BAB58CFD}" type="datetimeFigureOut">
              <a:rPr kumimoji="1" lang="zh-CN" altLang="en-US" smtClean="0"/>
              <a:t>2023/7/14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EAD65-65B7-DD44-9AD7-3EEB34CD8DE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67621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60014"/>
            <a:ext cx="4644444" cy="3360050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2073367"/>
            <a:ext cx="7290108" cy="10233485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320064"/>
            <a:ext cx="4644444" cy="800345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0505D-F369-F641-B378-8C27BAB58CFD}" type="datetimeFigureOut">
              <a:rPr kumimoji="1" lang="zh-CN" altLang="en-US" smtClean="0"/>
              <a:t>2023/7/14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EAD65-65B7-DD44-9AD7-3EEB34CD8DE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640171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766681"/>
            <a:ext cx="12420184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3833390"/>
            <a:ext cx="12420184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3346867"/>
            <a:ext cx="324004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A0505D-F369-F641-B378-8C27BAB58CFD}" type="datetimeFigureOut">
              <a:rPr kumimoji="1" lang="zh-CN" altLang="en-US" smtClean="0"/>
              <a:t>2023/7/14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3346867"/>
            <a:ext cx="4860072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3346867"/>
            <a:ext cx="324004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2EAD65-65B7-DD44-9AD7-3EEB34CD8DE9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52409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B52892CA-1E2A-A04B-A717-14441A8BAA2A}"/>
              </a:ext>
            </a:extLst>
          </p:cNvPr>
          <p:cNvSpPr txBox="1"/>
          <p:nvPr/>
        </p:nvSpPr>
        <p:spPr>
          <a:xfrm>
            <a:off x="1953585" y="13332410"/>
            <a:ext cx="1098722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 </a:t>
            </a:r>
            <a:r>
              <a:rPr lang="en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edian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(IQR) sTK1 in overall patients and by treatment arms across timepoints </a:t>
            </a:r>
            <a:r>
              <a:rPr lang="en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格 3">
            <a:extLst>
              <a:ext uri="{FF2B5EF4-FFF2-40B4-BE49-F238E27FC236}">
                <a16:creationId xmlns:a16="http://schemas.microsoft.com/office/drawing/2014/main" id="{D6EE6C23-945C-2A41-867A-EE48578B534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0236623"/>
              </p:ext>
            </p:extLst>
          </p:nvPr>
        </p:nvGraphicFramePr>
        <p:xfrm>
          <a:off x="2091384" y="5723598"/>
          <a:ext cx="10174916" cy="746009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2543729">
                  <a:extLst>
                    <a:ext uri="{9D8B030D-6E8A-4147-A177-3AD203B41FA5}">
                      <a16:colId xmlns:a16="http://schemas.microsoft.com/office/drawing/2014/main" val="3946009261"/>
                    </a:ext>
                  </a:extLst>
                </a:gridCol>
                <a:gridCol w="2543729">
                  <a:extLst>
                    <a:ext uri="{9D8B030D-6E8A-4147-A177-3AD203B41FA5}">
                      <a16:colId xmlns:a16="http://schemas.microsoft.com/office/drawing/2014/main" val="3694240689"/>
                    </a:ext>
                  </a:extLst>
                </a:gridCol>
                <a:gridCol w="2543729">
                  <a:extLst>
                    <a:ext uri="{9D8B030D-6E8A-4147-A177-3AD203B41FA5}">
                      <a16:colId xmlns:a16="http://schemas.microsoft.com/office/drawing/2014/main" val="2831909327"/>
                    </a:ext>
                  </a:extLst>
                </a:gridCol>
                <a:gridCol w="2543729">
                  <a:extLst>
                    <a:ext uri="{9D8B030D-6E8A-4147-A177-3AD203B41FA5}">
                      <a16:colId xmlns:a16="http://schemas.microsoft.com/office/drawing/2014/main" val="1481183839"/>
                    </a:ext>
                  </a:extLst>
                </a:gridCol>
              </a:tblGrid>
              <a:tr h="339095">
                <a:tc>
                  <a:txBody>
                    <a:bodyPr/>
                    <a:lstStyle/>
                    <a:p>
                      <a:endParaRPr lang="zh-CN" alt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(IQR) </a:t>
                      </a:r>
                      <a:r>
                        <a:rPr lang="en-US" altLang="zh-CN" sz="1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A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,</a:t>
                      </a:r>
                      <a:r>
                        <a:rPr lang="zh-CN" alt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x</a:t>
                      </a:r>
                      <a:r>
                        <a:rPr lang="zh-CN" alt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A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4955531"/>
                  </a:ext>
                </a:extLst>
              </a:tr>
              <a:tr h="339095">
                <a:tc rowSpan="3"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line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36(79.53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, 545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8891999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a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.6(73.2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, 499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8149578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96(81.9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43999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, 545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47867383"/>
                  </a:ext>
                </a:extLst>
              </a:tr>
              <a:tr h="339095">
                <a:tc rowSpan="3"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it 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54(2762.0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5.8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18520426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a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2(2078.0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9.9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26403084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4(2777.4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5.8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35114560"/>
                  </a:ext>
                </a:extLst>
              </a:tr>
              <a:tr h="339095">
                <a:tc rowSpan="3"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it 2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5(2334.7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.6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36427574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a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5(670.1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.8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0500620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2(2051.0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43999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.6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36294585"/>
                  </a:ext>
                </a:extLst>
              </a:tr>
              <a:tr h="339095">
                <a:tc rowSpan="3"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it 3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2(1298.5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.8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56207724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a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1.1(737.3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8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86332830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85(2411.6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8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9285102"/>
                  </a:ext>
                </a:extLst>
              </a:tr>
              <a:tr h="339095">
                <a:tc rowSpan="3"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it 4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0(1935.2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99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26536957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a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7.8(709.3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99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2690698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68(2420.7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40944839"/>
                  </a:ext>
                </a:extLst>
              </a:tr>
              <a:tr h="339095">
                <a:tc rowSpan="3"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it </a:t>
                      </a:r>
                      <a:r>
                        <a:rPr lang="en-US" altLang="zh-CN" sz="16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oT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2(1011.4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70215184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a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4.9(1216.5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53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8413140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6(437.1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43999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, 308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53473641"/>
                  </a:ext>
                </a:extLst>
              </a:tr>
              <a:tr h="339095">
                <a:tc rowSpan="3"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it FU1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79(50.96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, 2512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66380586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al 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43999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(53.39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43999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, 612.9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54413264"/>
                  </a:ext>
                </a:extLst>
              </a:tr>
              <a:tr h="339095">
                <a:tc vMerge="1">
                  <a:txBody>
                    <a:bodyPr/>
                    <a:lstStyle/>
                    <a:p>
                      <a:endParaRPr lang="zh-CN" altLang="en-US" sz="2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43999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55(41.41)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143999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, 2512</a:t>
                      </a:r>
                      <a:endParaRPr lang="zh-CN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1626412"/>
                  </a:ext>
                </a:extLst>
              </a:tr>
            </a:tbl>
          </a:graphicData>
        </a:graphic>
      </p:graphicFrame>
      <p:sp>
        <p:nvSpPr>
          <p:cNvPr id="8" name="文本框 7">
            <a:extLst>
              <a:ext uri="{FF2B5EF4-FFF2-40B4-BE49-F238E27FC236}">
                <a16:creationId xmlns:a16="http://schemas.microsoft.com/office/drawing/2014/main" id="{50E22E7F-BA9C-1D4E-9486-7E64E626DB7A}"/>
              </a:ext>
            </a:extLst>
          </p:cNvPr>
          <p:cNvSpPr txBox="1"/>
          <p:nvPr/>
        </p:nvSpPr>
        <p:spPr>
          <a:xfrm>
            <a:off x="3805989" y="4803845"/>
            <a:ext cx="544952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</a:t>
            </a:r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low diagram of patients</a:t>
            </a: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05BA675B-E1DD-0348-8DAF-69F369136C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07146" y="898526"/>
            <a:ext cx="5880100" cy="3987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8193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">
            <a:extLst>
              <a:ext uri="{FF2B5EF4-FFF2-40B4-BE49-F238E27FC236}">
                <a16:creationId xmlns:a16="http://schemas.microsoft.com/office/drawing/2014/main" id="{D090D164-BAAB-9547-AC12-50D6C97C24E1}"/>
              </a:ext>
            </a:extLst>
          </p:cNvPr>
          <p:cNvSpPr txBox="1"/>
          <p:nvPr/>
        </p:nvSpPr>
        <p:spPr>
          <a:xfrm>
            <a:off x="1261923" y="12877039"/>
            <a:ext cx="1187636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upplementary figure 2. A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median TK1 mRNA change of all patients by </a:t>
            </a:r>
            <a:r>
              <a:rPr lang="en-US" altLang="zh-CN" sz="1600" kern="1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CR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status </a:t>
            </a:r>
            <a:r>
              <a:rPr lang="en-US" altLang="zh-CN" sz="16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Number of patients of three TK1 groups categorized by median of available values in respective timepoints and relationship to </a:t>
            </a:r>
            <a:r>
              <a:rPr lang="en-US" altLang="zh-CN" sz="1600" kern="1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CR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outcome per treatment group</a:t>
            </a:r>
            <a:endParaRPr lang="en-US" altLang="zh-CN" sz="1600" b="1" kern="100" dirty="0"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8332DDD-8045-B843-A084-A60CF657BCAD}"/>
              </a:ext>
            </a:extLst>
          </p:cNvPr>
          <p:cNvSpPr txBox="1"/>
          <p:nvPr/>
        </p:nvSpPr>
        <p:spPr>
          <a:xfrm>
            <a:off x="5091783" y="5938150"/>
            <a:ext cx="1097280" cy="467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38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zh-CN" altLang="en-US" sz="243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E430BFBC-A8D8-0041-A292-3DF126318198}"/>
              </a:ext>
            </a:extLst>
          </p:cNvPr>
          <p:cNvSpPr txBox="1"/>
          <p:nvPr/>
        </p:nvSpPr>
        <p:spPr>
          <a:xfrm>
            <a:off x="1095105" y="7535803"/>
            <a:ext cx="1097280" cy="467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438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zh-CN" altLang="en-US" sz="243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格 24">
            <a:extLst>
              <a:ext uri="{FF2B5EF4-FFF2-40B4-BE49-F238E27FC236}">
                <a16:creationId xmlns:a16="http://schemas.microsoft.com/office/drawing/2014/main" id="{7E751CF5-2F0E-2E27-3137-C77DBC7C1A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1444547"/>
              </p:ext>
            </p:extLst>
          </p:nvPr>
        </p:nvGraphicFramePr>
        <p:xfrm>
          <a:off x="1358037" y="508080"/>
          <a:ext cx="11780252" cy="3886961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475181">
                  <a:extLst>
                    <a:ext uri="{9D8B030D-6E8A-4147-A177-3AD203B41FA5}">
                      <a16:colId xmlns:a16="http://schemas.microsoft.com/office/drawing/2014/main" val="3901321058"/>
                    </a:ext>
                  </a:extLst>
                </a:gridCol>
                <a:gridCol w="2009714">
                  <a:extLst>
                    <a:ext uri="{9D8B030D-6E8A-4147-A177-3AD203B41FA5}">
                      <a16:colId xmlns:a16="http://schemas.microsoft.com/office/drawing/2014/main" val="114946078"/>
                    </a:ext>
                  </a:extLst>
                </a:gridCol>
                <a:gridCol w="1354751">
                  <a:extLst>
                    <a:ext uri="{9D8B030D-6E8A-4147-A177-3AD203B41FA5}">
                      <a16:colId xmlns:a16="http://schemas.microsoft.com/office/drawing/2014/main" val="3545621794"/>
                    </a:ext>
                  </a:extLst>
                </a:gridCol>
                <a:gridCol w="992581">
                  <a:extLst>
                    <a:ext uri="{9D8B030D-6E8A-4147-A177-3AD203B41FA5}">
                      <a16:colId xmlns:a16="http://schemas.microsoft.com/office/drawing/2014/main" val="1562564571"/>
                    </a:ext>
                  </a:extLst>
                </a:gridCol>
                <a:gridCol w="992581">
                  <a:extLst>
                    <a:ext uri="{9D8B030D-6E8A-4147-A177-3AD203B41FA5}">
                      <a16:colId xmlns:a16="http://schemas.microsoft.com/office/drawing/2014/main" val="846800318"/>
                    </a:ext>
                  </a:extLst>
                </a:gridCol>
                <a:gridCol w="1377459">
                  <a:extLst>
                    <a:ext uri="{9D8B030D-6E8A-4147-A177-3AD203B41FA5}">
                      <a16:colId xmlns:a16="http://schemas.microsoft.com/office/drawing/2014/main" val="2964422143"/>
                    </a:ext>
                  </a:extLst>
                </a:gridCol>
                <a:gridCol w="1690003">
                  <a:extLst>
                    <a:ext uri="{9D8B030D-6E8A-4147-A177-3AD203B41FA5}">
                      <a16:colId xmlns:a16="http://schemas.microsoft.com/office/drawing/2014/main" val="131396211"/>
                    </a:ext>
                  </a:extLst>
                </a:gridCol>
                <a:gridCol w="943991">
                  <a:extLst>
                    <a:ext uri="{9D8B030D-6E8A-4147-A177-3AD203B41FA5}">
                      <a16:colId xmlns:a16="http://schemas.microsoft.com/office/drawing/2014/main" val="145732709"/>
                    </a:ext>
                  </a:extLst>
                </a:gridCol>
                <a:gridCol w="943991">
                  <a:extLst>
                    <a:ext uri="{9D8B030D-6E8A-4147-A177-3AD203B41FA5}">
                      <a16:colId xmlns:a16="http://schemas.microsoft.com/office/drawing/2014/main" val="2394639016"/>
                    </a:ext>
                  </a:extLst>
                </a:gridCol>
              </a:tblGrid>
              <a:tr h="603423">
                <a:tc>
                  <a:txBody>
                    <a:bodyPr/>
                    <a:lstStyle/>
                    <a:p>
                      <a:endParaRPr lang="zh-CN" altLang="en-US" sz="16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availab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detectable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</a:t>
                      </a:r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</a:t>
                      </a:r>
                      <a:r>
                        <a:rPr lang="zh-CN" alt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ge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-square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90302460"/>
                  </a:ext>
                </a:extLst>
              </a:tr>
              <a:tr h="595576">
                <a:tc rowSpan="2"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it 2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al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23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37391748"/>
                  </a:ext>
                </a:extLst>
              </a:tr>
              <a:tr h="348731">
                <a:tc vMerge="1">
                  <a:txBody>
                    <a:bodyPr/>
                    <a:lstStyle/>
                    <a:p>
                      <a:endParaRPr lang="zh-CN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 sz="14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2178031"/>
                  </a:ext>
                </a:extLst>
              </a:tr>
              <a:tr h="595576">
                <a:tc rowSpan="2"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it 4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al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87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l" defTabSz="143999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23901165"/>
                  </a:ext>
                </a:extLst>
              </a:tr>
              <a:tr h="348731">
                <a:tc vMerge="1">
                  <a:txBody>
                    <a:bodyPr/>
                    <a:lstStyle/>
                    <a:p>
                      <a:endParaRPr lang="zh-CN" alt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 sz="1400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 sz="14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7386487"/>
                  </a:ext>
                </a:extLst>
              </a:tr>
              <a:tr h="348731">
                <a:tc rowSpan="2"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it </a:t>
                      </a:r>
                      <a:r>
                        <a:rPr lang="en-US" altLang="zh-CN" sz="16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oT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al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,64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l" defTabSz="143999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 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143999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91347302"/>
                  </a:ext>
                </a:extLst>
              </a:tr>
              <a:tr h="348731">
                <a:tc vMerge="1">
                  <a:txBody>
                    <a:bodyPr/>
                    <a:lstStyle/>
                    <a:p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l" defTabSz="143999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8721353"/>
                  </a:ext>
                </a:extLst>
              </a:tr>
              <a:tr h="348731">
                <a:tc rowSpan="2"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it FU1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al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85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l" defTabSz="143999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6503724"/>
                  </a:ext>
                </a:extLst>
              </a:tr>
              <a:tr h="348731">
                <a:tc vMerge="1">
                  <a:txBody>
                    <a:bodyPr/>
                    <a:lstStyle/>
                    <a:p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l" defTabSz="143999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41986147"/>
                  </a:ext>
                </a:extLst>
              </a:tr>
            </a:tbl>
          </a:graphicData>
        </a:graphic>
      </p:graphicFrame>
      <p:sp>
        <p:nvSpPr>
          <p:cNvPr id="21" name="文本框 9">
            <a:extLst>
              <a:ext uri="{FF2B5EF4-FFF2-40B4-BE49-F238E27FC236}">
                <a16:creationId xmlns:a16="http://schemas.microsoft.com/office/drawing/2014/main" id="{EFFC2121-4C48-280C-B2E5-CA7E1E13C5B5}"/>
              </a:ext>
            </a:extLst>
          </p:cNvPr>
          <p:cNvSpPr txBox="1"/>
          <p:nvPr/>
        </p:nvSpPr>
        <p:spPr>
          <a:xfrm>
            <a:off x="1261923" y="4544258"/>
            <a:ext cx="1178025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</a:t>
            </a:r>
            <a:r>
              <a: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sTK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roportions by treatment groups at visit 2, visit 4, visit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EoT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and visit FU1</a:t>
            </a:r>
            <a:endParaRPr lang="en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09B984F1-17B1-3243-90DF-BE25F1C3DF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91783" y="6427864"/>
            <a:ext cx="4403255" cy="2896878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5620B2B0-52D7-B04E-A890-B394998A05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26801" y="6427864"/>
            <a:ext cx="4548034" cy="3150878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7200E7EC-A795-1648-A4CB-6D2E79F2B12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09379" y="9942281"/>
            <a:ext cx="4320886" cy="2896879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DB24878C-68BC-D64A-99D0-B83AC855C8E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95105" y="8058049"/>
            <a:ext cx="4041612" cy="28968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63432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C86A466-9953-734F-9D15-46FB432715A2}"/>
              </a:ext>
            </a:extLst>
          </p:cNvPr>
          <p:cNvSpPr txBox="1"/>
          <p:nvPr/>
        </p:nvSpPr>
        <p:spPr>
          <a:xfrm>
            <a:off x="1903191" y="5586745"/>
            <a:ext cx="1097643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upplementary Figure 3 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FS</a:t>
            </a:r>
            <a:r>
              <a:rPr lang="zh-CN" altLang="en-US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robability</a:t>
            </a:r>
            <a:r>
              <a:rPr lang="zh-CN" altLang="en-US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ccording</a:t>
            </a:r>
            <a:r>
              <a:rPr lang="zh-CN" altLang="en-US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to </a:t>
            </a:r>
            <a:r>
              <a:rPr lang="en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TK1 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ctivity</a:t>
            </a:r>
            <a:r>
              <a:rPr lang="en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at visit </a:t>
            </a:r>
            <a:r>
              <a:rPr lang="en" altLang="zh-CN" sz="1600" kern="1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EoT</a:t>
            </a:r>
            <a:r>
              <a:rPr lang="en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y</a:t>
            </a:r>
            <a:r>
              <a:rPr lang="zh-CN" altLang="en-US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median value(422 </a:t>
            </a:r>
            <a:r>
              <a:rPr lang="en-US" altLang="zh-CN" sz="1600" kern="1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uA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</a:t>
            </a:r>
            <a:r>
              <a:rPr lang="zh-CN" altLang="en-US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s cut-off </a:t>
            </a:r>
            <a:r>
              <a:rPr lang="zh-CN" altLang="en-US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r>
              <a:rPr lang="en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Du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as cut-off in all patients</a:t>
            </a:r>
            <a:endParaRPr lang="zh-CN" altLang="zh-CN" sz="1600" kern="100" dirty="0"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85D053FF-E6CC-064B-94EA-8BC2E985C8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374270"/>
              </p:ext>
            </p:extLst>
          </p:nvPr>
        </p:nvGraphicFramePr>
        <p:xfrm>
          <a:off x="2304154" y="7936515"/>
          <a:ext cx="9791904" cy="2228899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2744158">
                  <a:extLst>
                    <a:ext uri="{9D8B030D-6E8A-4147-A177-3AD203B41FA5}">
                      <a16:colId xmlns:a16="http://schemas.microsoft.com/office/drawing/2014/main" val="2196179617"/>
                    </a:ext>
                  </a:extLst>
                </a:gridCol>
                <a:gridCol w="1891685">
                  <a:extLst>
                    <a:ext uri="{9D8B030D-6E8A-4147-A177-3AD203B41FA5}">
                      <a16:colId xmlns:a16="http://schemas.microsoft.com/office/drawing/2014/main" val="2739634292"/>
                    </a:ext>
                  </a:extLst>
                </a:gridCol>
                <a:gridCol w="1718283">
                  <a:extLst>
                    <a:ext uri="{9D8B030D-6E8A-4147-A177-3AD203B41FA5}">
                      <a16:colId xmlns:a16="http://schemas.microsoft.com/office/drawing/2014/main" val="3197477874"/>
                    </a:ext>
                  </a:extLst>
                </a:gridCol>
                <a:gridCol w="1718283">
                  <a:extLst>
                    <a:ext uri="{9D8B030D-6E8A-4147-A177-3AD203B41FA5}">
                      <a16:colId xmlns:a16="http://schemas.microsoft.com/office/drawing/2014/main" val="758662000"/>
                    </a:ext>
                  </a:extLst>
                </a:gridCol>
                <a:gridCol w="1719495">
                  <a:extLst>
                    <a:ext uri="{9D8B030D-6E8A-4147-A177-3AD203B41FA5}">
                      <a16:colId xmlns:a16="http://schemas.microsoft.com/office/drawing/2014/main" val="2771434878"/>
                    </a:ext>
                  </a:extLst>
                </a:gridCol>
              </a:tblGrid>
              <a:tr h="495311">
                <a:tc>
                  <a:txBody>
                    <a:bodyPr/>
                    <a:lstStyle/>
                    <a:p>
                      <a:pPr algn="just"/>
                      <a:r>
                        <a:rPr lang="en-US" sz="1600" b="0" kern="100" dirty="0">
                          <a:effectLst/>
                          <a:latin typeface="+mn-lt"/>
                        </a:rPr>
                        <a:t> 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1600" b="1" kern="100" dirty="0">
                          <a:effectLst/>
                          <a:latin typeface="+mn-lt"/>
                        </a:rPr>
                        <a:t>Cox regression</a:t>
                      </a:r>
                      <a:endParaRPr lang="zh-CN" sz="1600" b="1" kern="100" dirty="0">
                        <a:effectLst/>
                        <a:latin typeface="+mn-lt"/>
                      </a:endParaRPr>
                    </a:p>
                    <a:p>
                      <a:pPr algn="ctr"/>
                      <a:r>
                        <a:rPr lang="en-US" sz="1600" b="1" kern="100" dirty="0">
                          <a:effectLst/>
                          <a:latin typeface="+mn-lt"/>
                        </a:rPr>
                        <a:t>Hazard ratio (95% confidence interval)</a:t>
                      </a:r>
                      <a:endParaRPr lang="zh-CN" sz="1600" b="1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56224216"/>
                  </a:ext>
                </a:extLst>
              </a:tr>
              <a:tr h="495311">
                <a:tc>
                  <a:txBody>
                    <a:bodyPr/>
                    <a:lstStyle/>
                    <a:p>
                      <a:pPr algn="just"/>
                      <a:r>
                        <a:rPr lang="en-US" sz="1600" b="0" kern="100" dirty="0">
                          <a:effectLst/>
                          <a:latin typeface="+mn-lt"/>
                        </a:rPr>
                        <a:t> 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600" b="1" kern="100" dirty="0">
                          <a:effectLst/>
                          <a:latin typeface="+mn-lt"/>
                        </a:rPr>
                        <a:t>Unadjusted</a:t>
                      </a:r>
                      <a:endParaRPr lang="zh-CN" sz="1600" b="1" kern="100" dirty="0">
                        <a:effectLst/>
                        <a:latin typeface="+mn-lt"/>
                      </a:endParaRPr>
                    </a:p>
                    <a:p>
                      <a:pPr algn="ctr"/>
                      <a:r>
                        <a:rPr lang="en-US" sz="1600" b="1" kern="100" dirty="0">
                          <a:effectLst/>
                          <a:latin typeface="+mn-lt"/>
                        </a:rPr>
                        <a:t>Model</a:t>
                      </a:r>
                      <a:endParaRPr lang="zh-CN" sz="1600" b="1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600" b="1" kern="100" dirty="0">
                          <a:effectLst/>
                          <a:latin typeface="+mn-lt"/>
                        </a:rPr>
                        <a:t>Adjusted</a:t>
                      </a:r>
                      <a:endParaRPr lang="zh-CN" sz="1600" b="1" kern="100" dirty="0">
                        <a:effectLst/>
                        <a:latin typeface="+mn-lt"/>
                      </a:endParaRPr>
                    </a:p>
                    <a:p>
                      <a:pPr algn="ctr"/>
                      <a:r>
                        <a:rPr lang="en-US" sz="1600" b="1" kern="100" dirty="0" err="1">
                          <a:effectLst/>
                          <a:latin typeface="+mn-lt"/>
                        </a:rPr>
                        <a:t>Model</a:t>
                      </a:r>
                      <a:r>
                        <a:rPr lang="en-US" sz="1600" b="1" kern="100" baseline="30000" dirty="0" err="1">
                          <a:effectLst/>
                          <a:latin typeface="+mn-lt"/>
                        </a:rPr>
                        <a:t>a</a:t>
                      </a:r>
                      <a:endParaRPr lang="zh-CN" sz="1600" b="1" kern="100" baseline="300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46610764"/>
                  </a:ext>
                </a:extLst>
              </a:tr>
              <a:tr h="247655">
                <a:tc>
                  <a:txBody>
                    <a:bodyPr/>
                    <a:lstStyle/>
                    <a:p>
                      <a:pPr algn="just"/>
                      <a:r>
                        <a:rPr lang="en-US" sz="1600" b="0" kern="100" dirty="0">
                          <a:effectLst/>
                          <a:latin typeface="+mn-lt"/>
                        </a:rPr>
                        <a:t> 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b="0" kern="100" dirty="0">
                          <a:effectLst/>
                          <a:latin typeface="+mn-lt"/>
                        </a:rPr>
                        <a:t>HR (95% CI)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b="0" kern="100">
                          <a:effectLst/>
                          <a:latin typeface="+mn-lt"/>
                        </a:rPr>
                        <a:t>P value</a:t>
                      </a:r>
                      <a:endParaRPr lang="zh-CN" sz="1600" b="0" kern="10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b="0" kern="100" dirty="0">
                          <a:effectLst/>
                          <a:latin typeface="+mn-lt"/>
                        </a:rPr>
                        <a:t>HR (95% CI)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600" b="0" kern="100" dirty="0">
                          <a:effectLst/>
                          <a:latin typeface="+mn-lt"/>
                        </a:rPr>
                        <a:t>P value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54515936"/>
                  </a:ext>
                </a:extLst>
              </a:tr>
              <a:tr h="495311"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kern="100" dirty="0">
                          <a:effectLst/>
                          <a:latin typeface="+mn-lt"/>
                        </a:rPr>
                        <a:t>TK1 at </a:t>
                      </a:r>
                      <a:r>
                        <a:rPr lang="en-US" sz="1600" b="1" kern="100" dirty="0" err="1">
                          <a:effectLst/>
                          <a:latin typeface="+mn-lt"/>
                        </a:rPr>
                        <a:t>EoT</a:t>
                      </a:r>
                      <a:r>
                        <a:rPr lang="en-US" sz="1600" b="1" kern="100" dirty="0">
                          <a:effectLst/>
                          <a:latin typeface="+mn-lt"/>
                        </a:rPr>
                        <a:t>(high vs low by</a:t>
                      </a:r>
                      <a:r>
                        <a:rPr lang="zh-CN" altLang="en-US" sz="1600" b="1" kern="10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600" b="1" kern="100" dirty="0">
                          <a:effectLst/>
                          <a:latin typeface="+mn-lt"/>
                        </a:rPr>
                        <a:t>cutoff</a:t>
                      </a:r>
                      <a:r>
                        <a:rPr lang="zh-CN" altLang="en-US" sz="1600" b="1" kern="10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sz="1600" b="1" kern="100" dirty="0">
                          <a:effectLst/>
                          <a:latin typeface="+mn-lt"/>
                        </a:rPr>
                        <a:t> 422 </a:t>
                      </a:r>
                      <a:r>
                        <a:rPr lang="en-US" sz="1600" b="1" kern="100" dirty="0" err="1">
                          <a:effectLst/>
                          <a:latin typeface="+mn-lt"/>
                        </a:rPr>
                        <a:t>Du</a:t>
                      </a:r>
                      <a:r>
                        <a:rPr lang="en-US" altLang="zh-CN" sz="1600" b="1" kern="100" dirty="0" err="1">
                          <a:effectLst/>
                          <a:latin typeface="+mn-lt"/>
                        </a:rPr>
                        <a:t>A</a:t>
                      </a:r>
                      <a:r>
                        <a:rPr lang="en-US" sz="1600" b="1" kern="100" dirty="0">
                          <a:effectLst/>
                          <a:latin typeface="+mn-lt"/>
                        </a:rPr>
                        <a:t>)</a:t>
                      </a:r>
                      <a:endParaRPr lang="zh-CN" sz="1600" b="1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0" kern="100" dirty="0">
                          <a:effectLst/>
                          <a:latin typeface="+mn-lt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.288(0.51-3.251)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0" kern="100" dirty="0">
                          <a:effectLst/>
                          <a:latin typeface="+mn-lt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0.592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0" kern="100" dirty="0">
                          <a:effectLst/>
                          <a:latin typeface="+mn-lt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.914(0.538-6.809)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0" kern="100" dirty="0">
                          <a:effectLst/>
                          <a:latin typeface="+mn-lt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0.316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3856109"/>
                  </a:ext>
                </a:extLst>
              </a:tr>
              <a:tr h="495311"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1" kern="100" dirty="0">
                          <a:effectLst/>
                          <a:latin typeface="+mn-lt"/>
                        </a:rPr>
                        <a:t>TK1 at </a:t>
                      </a:r>
                      <a:r>
                        <a:rPr lang="en-US" altLang="zh-CN" sz="1600" b="1" kern="100" dirty="0" err="1">
                          <a:effectLst/>
                          <a:latin typeface="+mn-lt"/>
                        </a:rPr>
                        <a:t>EoT</a:t>
                      </a:r>
                      <a:r>
                        <a:rPr lang="en-US" altLang="zh-CN" sz="1600" b="1" kern="100" dirty="0">
                          <a:effectLst/>
                          <a:latin typeface="+mn-lt"/>
                        </a:rPr>
                        <a:t>(high vs low by</a:t>
                      </a:r>
                      <a:r>
                        <a:rPr lang="zh-CN" altLang="en-US" sz="1600" b="1" kern="100" dirty="0">
                          <a:effectLst/>
                          <a:latin typeface="+mn-lt"/>
                        </a:rPr>
                        <a:t> </a:t>
                      </a:r>
                      <a:r>
                        <a:rPr lang="en-US" altLang="zh-CN" sz="1600" b="1" kern="100" dirty="0">
                          <a:effectLst/>
                          <a:latin typeface="+mn-lt"/>
                        </a:rPr>
                        <a:t>cutoff 250 </a:t>
                      </a:r>
                      <a:r>
                        <a:rPr lang="en-US" altLang="zh-CN" sz="1600" b="1" kern="100" dirty="0" err="1">
                          <a:effectLst/>
                          <a:latin typeface="+mn-lt"/>
                        </a:rPr>
                        <a:t>DuA</a:t>
                      </a:r>
                      <a:r>
                        <a:rPr lang="en-US" altLang="zh-CN" sz="1600" b="1" kern="100" dirty="0">
                          <a:effectLst/>
                          <a:latin typeface="+mn-lt"/>
                        </a:rPr>
                        <a:t>)</a:t>
                      </a:r>
                      <a:endParaRPr lang="zh-CN" altLang="zh-CN" sz="1600" b="1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0" kern="100" dirty="0">
                          <a:effectLst/>
                          <a:latin typeface="+mn-lt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.259(0.487-3.253)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0" kern="100" dirty="0">
                          <a:effectLst/>
                          <a:latin typeface="+mn-lt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0.634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0" kern="100" dirty="0">
                          <a:effectLst/>
                          <a:latin typeface="+mn-lt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1.508(0.328-6.937)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600" b="0" kern="100" dirty="0">
                          <a:effectLst/>
                          <a:latin typeface="+mn-lt"/>
                          <a:ea typeface="DengXian" panose="02010600030101010101" pitchFamily="2" charset="-122"/>
                          <a:cs typeface="Times New Roman" panose="02020603050405020304" pitchFamily="18" charset="0"/>
                        </a:rPr>
                        <a:t>0.598</a:t>
                      </a:r>
                      <a:endParaRPr lang="zh-CN" sz="1600" b="0" kern="100" dirty="0">
                        <a:effectLst/>
                        <a:latin typeface="+mn-lt"/>
                        <a:ea typeface="DengXia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3096512"/>
                  </a:ext>
                </a:extLst>
              </a:tr>
            </a:tbl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1940C79E-46CB-854D-B810-EFDE73B2D7BD}"/>
              </a:ext>
            </a:extLst>
          </p:cNvPr>
          <p:cNvSpPr txBox="1"/>
          <p:nvPr/>
        </p:nvSpPr>
        <p:spPr>
          <a:xfrm>
            <a:off x="1711891" y="10508234"/>
            <a:ext cx="1097643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upplementary Table 4</a:t>
            </a:r>
            <a:r>
              <a:rPr lang="zh-CN" altLang="en-US" sz="16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TK1 level at baseline, visit </a:t>
            </a:r>
            <a:r>
              <a:rPr lang="en" altLang="zh-CN" sz="1600" kern="1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EoT</a:t>
            </a:r>
            <a:r>
              <a:rPr lang="en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and its 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ssociation</a:t>
            </a:r>
            <a:r>
              <a:rPr lang="en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with</a:t>
            </a:r>
            <a:r>
              <a:rPr lang="zh-CN" altLang="en-US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isease-free survival (DFS) </a:t>
            </a:r>
          </a:p>
          <a:p>
            <a:pPr algn="just"/>
            <a:r>
              <a:rPr lang="en" altLang="zh-CN" sz="1600" kern="100" baseline="300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Adjusted for </a:t>
            </a:r>
            <a:r>
              <a:rPr lang="en" altLang="zh-CN" sz="1600" kern="100" dirty="0" err="1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CR</a:t>
            </a:r>
            <a:r>
              <a:rPr lang="en" altLang="zh-CN" sz="16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, Ki67, treatment arm, tumor grade, tumor size, ER status and node status.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FB5AFD4-54C0-1544-B703-C7D4B79A28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56870" y="816241"/>
            <a:ext cx="5555483" cy="472007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B4F59EA-D2EB-1F40-95F2-FEF6262F3D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3191" y="1003307"/>
            <a:ext cx="5035937" cy="43459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97859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9827</TotalTime>
  <Words>453</Words>
  <Application>Microsoft Macintosh PowerPoint</Application>
  <PresentationFormat>Custom</PresentationFormat>
  <Paragraphs>172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 User</dc:creator>
  <cp:lastModifiedBy>Yajing Zhu</cp:lastModifiedBy>
  <cp:revision>719</cp:revision>
  <dcterms:created xsi:type="dcterms:W3CDTF">2023-01-18T16:11:52Z</dcterms:created>
  <dcterms:modified xsi:type="dcterms:W3CDTF">2023-07-14T18:31:32Z</dcterms:modified>
</cp:coreProperties>
</file>